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6" autoAdjust="0"/>
    <p:restoredTop sz="83002" autoAdjust="0"/>
  </p:normalViewPr>
  <p:slideViewPr>
    <p:cSldViewPr snapToGrid="0">
      <p:cViewPr varScale="1">
        <p:scale>
          <a:sx n="81" d="100"/>
          <a:sy n="81" d="100"/>
        </p:scale>
        <p:origin x="52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MOTO Yoshinori" userId="160c10375ccca3ba" providerId="LiveId" clId="{1C3A666B-3D52-4FF2-84F8-5223B37DC62A}"/>
    <pc:docChg chg="undo redo custSel addSld delSld modSld sldOrd">
      <pc:chgData name="OKAMOTO Yoshinori" userId="160c10375ccca3ba" providerId="LiveId" clId="{1C3A666B-3D52-4FF2-84F8-5223B37DC62A}" dt="2025-06-14T07:33:26.492" v="643" actId="12788"/>
      <pc:docMkLst>
        <pc:docMk/>
      </pc:docMkLst>
      <pc:sldChg chg="del">
        <pc:chgData name="OKAMOTO Yoshinori" userId="160c10375ccca3ba" providerId="LiveId" clId="{1C3A666B-3D52-4FF2-84F8-5223B37DC62A}" dt="2025-05-15T10:32:30.838" v="0" actId="47"/>
        <pc:sldMkLst>
          <pc:docMk/>
          <pc:sldMk cId="820113535" sldId="256"/>
        </pc:sldMkLst>
      </pc:sldChg>
      <pc:sldChg chg="del">
        <pc:chgData name="OKAMOTO Yoshinori" userId="160c10375ccca3ba" providerId="LiveId" clId="{1C3A666B-3D52-4FF2-84F8-5223B37DC62A}" dt="2025-05-15T10:32:30.838" v="0" actId="47"/>
        <pc:sldMkLst>
          <pc:docMk/>
          <pc:sldMk cId="1695356681" sldId="257"/>
        </pc:sldMkLst>
      </pc:sldChg>
      <pc:sldChg chg="del">
        <pc:chgData name="OKAMOTO Yoshinori" userId="160c10375ccca3ba" providerId="LiveId" clId="{1C3A666B-3D52-4FF2-84F8-5223B37DC62A}" dt="2025-05-15T10:32:30.838" v="0" actId="47"/>
        <pc:sldMkLst>
          <pc:docMk/>
          <pc:sldMk cId="1803968296" sldId="259"/>
        </pc:sldMkLst>
      </pc:sldChg>
      <pc:sldChg chg="del">
        <pc:chgData name="OKAMOTO Yoshinori" userId="160c10375ccca3ba" providerId="LiveId" clId="{1C3A666B-3D52-4FF2-84F8-5223B37DC62A}" dt="2025-05-15T10:32:30.838" v="0" actId="47"/>
        <pc:sldMkLst>
          <pc:docMk/>
          <pc:sldMk cId="1268993489" sldId="260"/>
        </pc:sldMkLst>
      </pc:sldChg>
      <pc:sldChg chg="modSp add del mod ord">
        <pc:chgData name="OKAMOTO Yoshinori" userId="160c10375ccca3ba" providerId="LiveId" clId="{1C3A666B-3D52-4FF2-84F8-5223B37DC62A}" dt="2025-05-16T04:12:46.721" v="319" actId="47"/>
        <pc:sldMkLst>
          <pc:docMk/>
          <pc:sldMk cId="2473991852" sldId="261"/>
        </pc:sldMkLst>
      </pc:sldChg>
      <pc:sldChg chg="addSp delSp modSp new mod modNotesTx">
        <pc:chgData name="OKAMOTO Yoshinori" userId="160c10375ccca3ba" providerId="LiveId" clId="{1C3A666B-3D52-4FF2-84F8-5223B37DC62A}" dt="2025-06-14T07:33:26.492" v="643" actId="12788"/>
        <pc:sldMkLst>
          <pc:docMk/>
          <pc:sldMk cId="3966340514" sldId="262"/>
        </pc:sldMkLst>
        <pc:spChg chg="add mod">
          <ac:chgData name="OKAMOTO Yoshinori" userId="160c10375ccca3ba" providerId="LiveId" clId="{1C3A666B-3D52-4FF2-84F8-5223B37DC62A}" dt="2025-06-14T07:33:22.734" v="642" actId="164"/>
          <ac:spMkLst>
            <pc:docMk/>
            <pc:sldMk cId="3966340514" sldId="262"/>
            <ac:spMk id="5" creationId="{226584BE-81C3-CC7A-4427-AFF8A3A157F4}"/>
          </ac:spMkLst>
        </pc:spChg>
        <pc:spChg chg="add mod">
          <ac:chgData name="OKAMOTO Yoshinori" userId="160c10375ccca3ba" providerId="LiveId" clId="{1C3A666B-3D52-4FF2-84F8-5223B37DC62A}" dt="2025-06-14T07:33:22.734" v="642" actId="164"/>
          <ac:spMkLst>
            <pc:docMk/>
            <pc:sldMk cId="3966340514" sldId="262"/>
            <ac:spMk id="6" creationId="{49D4F826-8F0E-9018-12E5-621BD81B69F8}"/>
          </ac:spMkLst>
        </pc:spChg>
        <pc:spChg chg="add mod">
          <ac:chgData name="OKAMOTO Yoshinori" userId="160c10375ccca3ba" providerId="LiveId" clId="{1C3A666B-3D52-4FF2-84F8-5223B37DC62A}" dt="2025-06-14T07:33:22.734" v="642" actId="164"/>
          <ac:spMkLst>
            <pc:docMk/>
            <pc:sldMk cId="3966340514" sldId="262"/>
            <ac:spMk id="11" creationId="{BAE16CAB-DDDB-2F92-9818-32EC2EA7D75B}"/>
          </ac:spMkLst>
        </pc:spChg>
        <pc:spChg chg="add mod">
          <ac:chgData name="OKAMOTO Yoshinori" userId="160c10375ccca3ba" providerId="LiveId" clId="{1C3A666B-3D52-4FF2-84F8-5223B37DC62A}" dt="2025-06-14T07:33:22.734" v="642" actId="164"/>
          <ac:spMkLst>
            <pc:docMk/>
            <pc:sldMk cId="3966340514" sldId="262"/>
            <ac:spMk id="12" creationId="{0A0F60EE-4B93-29FC-95BE-092F4AA86D59}"/>
          </ac:spMkLst>
        </pc:spChg>
        <pc:grpChg chg="add mod">
          <ac:chgData name="OKAMOTO Yoshinori" userId="160c10375ccca3ba" providerId="LiveId" clId="{1C3A666B-3D52-4FF2-84F8-5223B37DC62A}" dt="2025-06-14T07:33:26.492" v="643" actId="12788"/>
          <ac:grpSpMkLst>
            <pc:docMk/>
            <pc:sldMk cId="3966340514" sldId="262"/>
            <ac:grpSpMk id="2" creationId="{5A29E5E2-9CAF-BC76-5A49-C6900D61BA05}"/>
          </ac:grpSpMkLst>
        </pc:grpChg>
        <pc:graphicFrameChg chg="add mod">
          <ac:chgData name="OKAMOTO Yoshinori" userId="160c10375ccca3ba" providerId="LiveId" clId="{1C3A666B-3D52-4FF2-84F8-5223B37DC62A}" dt="2025-06-14T07:33:22.734" v="642" actId="164"/>
          <ac:graphicFrameMkLst>
            <pc:docMk/>
            <pc:sldMk cId="3966340514" sldId="262"/>
            <ac:graphicFrameMk id="4" creationId="{2676B50E-4AAE-4763-AFD5-FE510C8AD230}"/>
          </ac:graphicFrameMkLst>
        </pc:graphicFrameChg>
      </pc:sldChg>
      <pc:sldChg chg="addSp delSp modSp new del mod">
        <pc:chgData name="OKAMOTO Yoshinori" userId="160c10375ccca3ba" providerId="LiveId" clId="{1C3A666B-3D52-4FF2-84F8-5223B37DC62A}" dt="2025-05-19T09:06:57.675" v="460" actId="2696"/>
        <pc:sldMkLst>
          <pc:docMk/>
          <pc:sldMk cId="3872299336" sldId="263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160c10375ccca3ba/&#12487;&#12473;&#12463;&#12488;&#12483;&#12503;/Spinopelvic%20mobility%20and%20THA%20outcomes/Spinopelvic%20mobility%20and%20THA%20outcom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Sup fig'!$A$2</c:f>
              <c:strCache>
                <c:ptCount val="1"/>
                <c:pt idx="0">
                  <c:v>C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Sup fig'!$K$2:$K$71</c:f>
              <c:numCache>
                <c:formatCode>0.0_ </c:formatCode>
                <c:ptCount val="70"/>
                <c:pt idx="0">
                  <c:v>0.61899999999999622</c:v>
                </c:pt>
                <c:pt idx="1">
                  <c:v>0.40899999999999892</c:v>
                </c:pt>
                <c:pt idx="2">
                  <c:v>1.2490000000000006</c:v>
                </c:pt>
                <c:pt idx="3">
                  <c:v>1.4589999999999996</c:v>
                </c:pt>
                <c:pt idx="4">
                  <c:v>-1.6910000000000025</c:v>
                </c:pt>
                <c:pt idx="5">
                  <c:v>-0.8510000000000062</c:v>
                </c:pt>
                <c:pt idx="6">
                  <c:v>-2.1110000000000042</c:v>
                </c:pt>
                <c:pt idx="7">
                  <c:v>-2.1110000000000042</c:v>
                </c:pt>
                <c:pt idx="8">
                  <c:v>-2.1110000000000042</c:v>
                </c:pt>
                <c:pt idx="9">
                  <c:v>-2.9510000000000076</c:v>
                </c:pt>
                <c:pt idx="10">
                  <c:v>-2.9510000000000076</c:v>
                </c:pt>
                <c:pt idx="11">
                  <c:v>-4.8410000000000082</c:v>
                </c:pt>
                <c:pt idx="12">
                  <c:v>-4.8410000000000082</c:v>
                </c:pt>
                <c:pt idx="13">
                  <c:v>-2.7410000000000068</c:v>
                </c:pt>
                <c:pt idx="14">
                  <c:v>-5.4710000000000107</c:v>
                </c:pt>
                <c:pt idx="15">
                  <c:v>-2.3210000000000122</c:v>
                </c:pt>
                <c:pt idx="16">
                  <c:v>5.5120000000000005</c:v>
                </c:pt>
                <c:pt idx="17">
                  <c:v>2.782</c:v>
                </c:pt>
                <c:pt idx="18">
                  <c:v>1.3119999999999976</c:v>
                </c:pt>
                <c:pt idx="19">
                  <c:v>1.3119999999999976</c:v>
                </c:pt>
                <c:pt idx="20">
                  <c:v>1.9419999999999966</c:v>
                </c:pt>
                <c:pt idx="21">
                  <c:v>1.1019999999999968</c:v>
                </c:pt>
                <c:pt idx="22">
                  <c:v>1.5219999999999967</c:v>
                </c:pt>
                <c:pt idx="23">
                  <c:v>0.68199999999999505</c:v>
                </c:pt>
                <c:pt idx="24">
                  <c:v>-0.57800000000000296</c:v>
                </c:pt>
                <c:pt idx="25">
                  <c:v>-0.36800000000000921</c:v>
                </c:pt>
                <c:pt idx="26">
                  <c:v>1.1019999999999932</c:v>
                </c:pt>
                <c:pt idx="27">
                  <c:v>-1.8380000000000081</c:v>
                </c:pt>
                <c:pt idx="28">
                  <c:v>-0.78800000000000736</c:v>
                </c:pt>
                <c:pt idx="29">
                  <c:v>-0.57800000000001006</c:v>
                </c:pt>
                <c:pt idx="30">
                  <c:v>-0.1580000000000048</c:v>
                </c:pt>
                <c:pt idx="31">
                  <c:v>-1.4180000000000099</c:v>
                </c:pt>
                <c:pt idx="32">
                  <c:v>-1.061000000000007</c:v>
                </c:pt>
                <c:pt idx="33">
                  <c:v>-1.6910000000000025</c:v>
                </c:pt>
                <c:pt idx="34">
                  <c:v>-2.7410000000000068</c:v>
                </c:pt>
                <c:pt idx="35">
                  <c:v>-0.8510000000000062</c:v>
                </c:pt>
                <c:pt idx="36">
                  <c:v>-2.7410000000000068</c:v>
                </c:pt>
                <c:pt idx="37">
                  <c:v>-2.9510000000000076</c:v>
                </c:pt>
                <c:pt idx="38">
                  <c:v>-1.9010000000000034</c:v>
                </c:pt>
                <c:pt idx="39">
                  <c:v>-1.9010000000000034</c:v>
                </c:pt>
                <c:pt idx="40">
                  <c:v>-2.3210000000000122</c:v>
                </c:pt>
                <c:pt idx="41">
                  <c:v>-2.9510000000000076</c:v>
                </c:pt>
                <c:pt idx="42">
                  <c:v>-1.4810000000000052</c:v>
                </c:pt>
                <c:pt idx="43">
                  <c:v>-5.051000000000009</c:v>
                </c:pt>
                <c:pt idx="44">
                  <c:v>-2.3210000000000122</c:v>
                </c:pt>
                <c:pt idx="45">
                  <c:v>-3.7910000000000039</c:v>
                </c:pt>
                <c:pt idx="46">
                  <c:v>-2.7410000000000068</c:v>
                </c:pt>
                <c:pt idx="47">
                  <c:v>-3.3710000000000093</c:v>
                </c:pt>
                <c:pt idx="48">
                  <c:v>4.041999999999998</c:v>
                </c:pt>
                <c:pt idx="49">
                  <c:v>5.0920000000000023</c:v>
                </c:pt>
                <c:pt idx="50">
                  <c:v>1.3119999999999976</c:v>
                </c:pt>
                <c:pt idx="51">
                  <c:v>1.5219999999999949</c:v>
                </c:pt>
                <c:pt idx="52">
                  <c:v>2.9920000000000009</c:v>
                </c:pt>
                <c:pt idx="53">
                  <c:v>5.1999999999996049E-2</c:v>
                </c:pt>
                <c:pt idx="54">
                  <c:v>1.1019999999999968</c:v>
                </c:pt>
                <c:pt idx="55">
                  <c:v>1.3119999999999976</c:v>
                </c:pt>
                <c:pt idx="56">
                  <c:v>1.7320000000000011</c:v>
                </c:pt>
                <c:pt idx="57">
                  <c:v>0.6819999999999915</c:v>
                </c:pt>
                <c:pt idx="58">
                  <c:v>1.1019999999999932</c:v>
                </c:pt>
                <c:pt idx="59">
                  <c:v>0.47199999999999065</c:v>
                </c:pt>
                <c:pt idx="60">
                  <c:v>-0.57800000000001006</c:v>
                </c:pt>
                <c:pt idx="61">
                  <c:v>0.6819999999999915</c:v>
                </c:pt>
                <c:pt idx="62">
                  <c:v>-0.36800000000000921</c:v>
                </c:pt>
                <c:pt idx="63">
                  <c:v>-0.1580000000000048</c:v>
                </c:pt>
                <c:pt idx="64">
                  <c:v>-1.2500000000000071</c:v>
                </c:pt>
                <c:pt idx="65">
                  <c:v>-0.41000000000000369</c:v>
                </c:pt>
                <c:pt idx="66">
                  <c:v>-1.8800000000000097</c:v>
                </c:pt>
                <c:pt idx="67">
                  <c:v>1.8999999999999986</c:v>
                </c:pt>
                <c:pt idx="68">
                  <c:v>-1.2500000000000071</c:v>
                </c:pt>
                <c:pt idx="69">
                  <c:v>-2.720000000000006</c:v>
                </c:pt>
              </c:numCache>
            </c:numRef>
          </c:xVal>
          <c:yVal>
            <c:numRef>
              <c:f>'Sup fig'!$B$2:$B$71</c:f>
              <c:numCache>
                <c:formatCode>0_);[Red]\(0\)</c:formatCode>
                <c:ptCount val="70"/>
                <c:pt idx="0">
                  <c:v>56</c:v>
                </c:pt>
                <c:pt idx="1">
                  <c:v>71</c:v>
                </c:pt>
                <c:pt idx="2">
                  <c:v>63</c:v>
                </c:pt>
                <c:pt idx="3">
                  <c:v>75</c:v>
                </c:pt>
                <c:pt idx="4">
                  <c:v>62</c:v>
                </c:pt>
                <c:pt idx="5">
                  <c:v>70</c:v>
                </c:pt>
                <c:pt idx="6">
                  <c:v>86</c:v>
                </c:pt>
                <c:pt idx="7">
                  <c:v>91</c:v>
                </c:pt>
                <c:pt idx="8">
                  <c:v>83</c:v>
                </c:pt>
                <c:pt idx="9">
                  <c:v>80</c:v>
                </c:pt>
                <c:pt idx="10">
                  <c:v>87</c:v>
                </c:pt>
                <c:pt idx="11">
                  <c:v>80</c:v>
                </c:pt>
                <c:pt idx="12">
                  <c:v>81</c:v>
                </c:pt>
                <c:pt idx="13">
                  <c:v>87</c:v>
                </c:pt>
                <c:pt idx="14">
                  <c:v>80</c:v>
                </c:pt>
                <c:pt idx="15">
                  <c:v>84</c:v>
                </c:pt>
                <c:pt idx="16">
                  <c:v>92</c:v>
                </c:pt>
                <c:pt idx="17">
                  <c:v>86</c:v>
                </c:pt>
                <c:pt idx="18">
                  <c:v>85</c:v>
                </c:pt>
                <c:pt idx="19">
                  <c:v>85</c:v>
                </c:pt>
                <c:pt idx="20">
                  <c:v>83</c:v>
                </c:pt>
                <c:pt idx="21">
                  <c:v>88</c:v>
                </c:pt>
                <c:pt idx="22">
                  <c:v>97</c:v>
                </c:pt>
                <c:pt idx="23">
                  <c:v>80</c:v>
                </c:pt>
                <c:pt idx="24">
                  <c:v>80</c:v>
                </c:pt>
                <c:pt idx="25">
                  <c:v>81</c:v>
                </c:pt>
                <c:pt idx="26">
                  <c:v>79</c:v>
                </c:pt>
                <c:pt idx="27">
                  <c:v>84</c:v>
                </c:pt>
                <c:pt idx="28">
                  <c:v>82</c:v>
                </c:pt>
                <c:pt idx="29">
                  <c:v>81</c:v>
                </c:pt>
                <c:pt idx="30">
                  <c:v>80</c:v>
                </c:pt>
                <c:pt idx="31">
                  <c:v>94</c:v>
                </c:pt>
                <c:pt idx="32">
                  <c:v>72</c:v>
                </c:pt>
                <c:pt idx="33">
                  <c:v>83</c:v>
                </c:pt>
                <c:pt idx="34">
                  <c:v>95</c:v>
                </c:pt>
                <c:pt idx="35">
                  <c:v>84</c:v>
                </c:pt>
                <c:pt idx="36">
                  <c:v>62</c:v>
                </c:pt>
                <c:pt idx="37">
                  <c:v>92</c:v>
                </c:pt>
                <c:pt idx="38">
                  <c:v>100</c:v>
                </c:pt>
                <c:pt idx="39">
                  <c:v>80</c:v>
                </c:pt>
                <c:pt idx="40">
                  <c:v>82</c:v>
                </c:pt>
                <c:pt idx="41">
                  <c:v>72</c:v>
                </c:pt>
                <c:pt idx="42">
                  <c:v>83</c:v>
                </c:pt>
                <c:pt idx="43">
                  <c:v>100</c:v>
                </c:pt>
                <c:pt idx="44">
                  <c:v>64</c:v>
                </c:pt>
                <c:pt idx="45">
                  <c:v>90</c:v>
                </c:pt>
                <c:pt idx="46">
                  <c:v>85</c:v>
                </c:pt>
                <c:pt idx="47">
                  <c:v>80</c:v>
                </c:pt>
                <c:pt idx="48">
                  <c:v>65</c:v>
                </c:pt>
                <c:pt idx="49">
                  <c:v>67</c:v>
                </c:pt>
                <c:pt idx="50">
                  <c:v>75.199999999999989</c:v>
                </c:pt>
                <c:pt idx="51">
                  <c:v>76.14</c:v>
                </c:pt>
                <c:pt idx="52">
                  <c:v>74.259999999999991</c:v>
                </c:pt>
                <c:pt idx="53">
                  <c:v>78.959999999999994</c:v>
                </c:pt>
                <c:pt idx="54">
                  <c:v>77.08</c:v>
                </c:pt>
                <c:pt idx="55">
                  <c:v>76.14</c:v>
                </c:pt>
                <c:pt idx="56">
                  <c:v>75.199999999999989</c:v>
                </c:pt>
                <c:pt idx="57">
                  <c:v>88.36</c:v>
                </c:pt>
                <c:pt idx="58">
                  <c:v>67.679999999999993</c:v>
                </c:pt>
                <c:pt idx="59">
                  <c:v>78.02</c:v>
                </c:pt>
                <c:pt idx="60">
                  <c:v>89.3</c:v>
                </c:pt>
                <c:pt idx="61">
                  <c:v>78.959999999999994</c:v>
                </c:pt>
                <c:pt idx="62">
                  <c:v>58.279999999999994</c:v>
                </c:pt>
                <c:pt idx="63">
                  <c:v>86.47999999999999</c:v>
                </c:pt>
                <c:pt idx="64">
                  <c:v>94</c:v>
                </c:pt>
                <c:pt idx="65">
                  <c:v>75.199999999999989</c:v>
                </c:pt>
                <c:pt idx="66">
                  <c:v>77.08</c:v>
                </c:pt>
                <c:pt idx="67">
                  <c:v>67.679999999999993</c:v>
                </c:pt>
                <c:pt idx="68">
                  <c:v>78.02</c:v>
                </c:pt>
                <c:pt idx="69">
                  <c:v>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D5D-443A-869F-94AA579ADD2D}"/>
            </c:ext>
          </c:extLst>
        </c:ser>
        <c:ser>
          <c:idx val="1"/>
          <c:order val="1"/>
          <c:tx>
            <c:strRef>
              <c:f>'Sup fig'!$A$72</c:f>
              <c:strCache>
                <c:ptCount val="1"/>
                <c:pt idx="0">
                  <c:v>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lgDash"/>
              </a:ln>
              <a:effectLst/>
            </c:spPr>
            <c:trendlineType val="linear"/>
            <c:dispRSqr val="0"/>
            <c:dispEq val="0"/>
          </c:trendline>
          <c:xVal>
            <c:numRef>
              <c:f>'Sup fig'!$K$72:$K$106</c:f>
              <c:numCache>
                <c:formatCode>0.0_ </c:formatCode>
                <c:ptCount val="35"/>
                <c:pt idx="0">
                  <c:v>0.90999999999999659</c:v>
                </c:pt>
                <c:pt idx="1">
                  <c:v>0.69999999999999574</c:v>
                </c:pt>
                <c:pt idx="2">
                  <c:v>-0.98000000000001108</c:v>
                </c:pt>
                <c:pt idx="3">
                  <c:v>0.48999999999999488</c:v>
                </c:pt>
                <c:pt idx="4">
                  <c:v>-2.4500000000000099</c:v>
                </c:pt>
                <c:pt idx="5">
                  <c:v>2.3589999999999982</c:v>
                </c:pt>
                <c:pt idx="6">
                  <c:v>-1.0010000000000048</c:v>
                </c:pt>
                <c:pt idx="7">
                  <c:v>-0.79100000000000392</c:v>
                </c:pt>
                <c:pt idx="8">
                  <c:v>-2.2610000000000099</c:v>
                </c:pt>
                <c:pt idx="9">
                  <c:v>-0.16100000000000847</c:v>
                </c:pt>
                <c:pt idx="10">
                  <c:v>1.5189999999999948</c:v>
                </c:pt>
                <c:pt idx="11">
                  <c:v>-1.6310000000000144</c:v>
                </c:pt>
                <c:pt idx="12">
                  <c:v>-2.8910000000000053</c:v>
                </c:pt>
                <c:pt idx="13">
                  <c:v>-3.1010000000000062</c:v>
                </c:pt>
                <c:pt idx="14">
                  <c:v>-0.37100000000000932</c:v>
                </c:pt>
                <c:pt idx="15">
                  <c:v>-3.7310000000000159</c:v>
                </c:pt>
                <c:pt idx="16">
                  <c:v>-3.7310000000000159</c:v>
                </c:pt>
                <c:pt idx="17">
                  <c:v>2.6319999999999943</c:v>
                </c:pt>
                <c:pt idx="18">
                  <c:v>2.6319999999999943</c:v>
                </c:pt>
                <c:pt idx="19">
                  <c:v>5.9920000000000009</c:v>
                </c:pt>
                <c:pt idx="20">
                  <c:v>1.5819999999999936</c:v>
                </c:pt>
                <c:pt idx="21">
                  <c:v>2.2119999999999962</c:v>
                </c:pt>
                <c:pt idx="22">
                  <c:v>0.53199999999999292</c:v>
                </c:pt>
                <c:pt idx="23">
                  <c:v>0.11199999999999832</c:v>
                </c:pt>
                <c:pt idx="24">
                  <c:v>2.4219999999999935</c:v>
                </c:pt>
                <c:pt idx="25">
                  <c:v>3.2619999999999969</c:v>
                </c:pt>
                <c:pt idx="26">
                  <c:v>-0.30800000000000693</c:v>
                </c:pt>
                <c:pt idx="27">
                  <c:v>0.95199999999999108</c:v>
                </c:pt>
                <c:pt idx="28">
                  <c:v>-0.30800000000000693</c:v>
                </c:pt>
                <c:pt idx="29">
                  <c:v>2.2119999999999962</c:v>
                </c:pt>
                <c:pt idx="30">
                  <c:v>2.8419999999999987</c:v>
                </c:pt>
                <c:pt idx="31">
                  <c:v>0.74199999999999733</c:v>
                </c:pt>
                <c:pt idx="32">
                  <c:v>-1.2110000000000056</c:v>
                </c:pt>
                <c:pt idx="33">
                  <c:v>-0.79100000000000392</c:v>
                </c:pt>
                <c:pt idx="34">
                  <c:v>-1.2110000000000056</c:v>
                </c:pt>
              </c:numCache>
            </c:numRef>
          </c:xVal>
          <c:yVal>
            <c:numRef>
              <c:f>'Sup fig'!$B$72:$B$106</c:f>
              <c:numCache>
                <c:formatCode>0_);[Red]\(0\)</c:formatCode>
                <c:ptCount val="35"/>
                <c:pt idx="0">
                  <c:v>79</c:v>
                </c:pt>
                <c:pt idx="1">
                  <c:v>78</c:v>
                </c:pt>
                <c:pt idx="2">
                  <c:v>67</c:v>
                </c:pt>
                <c:pt idx="3">
                  <c:v>95</c:v>
                </c:pt>
                <c:pt idx="4">
                  <c:v>60</c:v>
                </c:pt>
                <c:pt idx="5">
                  <c:v>86</c:v>
                </c:pt>
                <c:pt idx="6">
                  <c:v>69</c:v>
                </c:pt>
                <c:pt idx="7">
                  <c:v>79</c:v>
                </c:pt>
                <c:pt idx="8">
                  <c:v>78</c:v>
                </c:pt>
                <c:pt idx="9">
                  <c:v>78</c:v>
                </c:pt>
                <c:pt idx="10">
                  <c:v>84</c:v>
                </c:pt>
                <c:pt idx="11">
                  <c:v>74</c:v>
                </c:pt>
                <c:pt idx="12">
                  <c:v>54</c:v>
                </c:pt>
                <c:pt idx="13">
                  <c:v>58</c:v>
                </c:pt>
                <c:pt idx="14">
                  <c:v>75</c:v>
                </c:pt>
                <c:pt idx="15">
                  <c:v>64</c:v>
                </c:pt>
                <c:pt idx="16">
                  <c:v>58</c:v>
                </c:pt>
                <c:pt idx="17">
                  <c:v>66</c:v>
                </c:pt>
                <c:pt idx="18">
                  <c:v>64</c:v>
                </c:pt>
                <c:pt idx="19">
                  <c:v>84</c:v>
                </c:pt>
                <c:pt idx="20">
                  <c:v>60</c:v>
                </c:pt>
                <c:pt idx="21">
                  <c:v>64</c:v>
                </c:pt>
                <c:pt idx="22">
                  <c:v>55</c:v>
                </c:pt>
                <c:pt idx="23">
                  <c:v>73</c:v>
                </c:pt>
                <c:pt idx="24">
                  <c:v>54</c:v>
                </c:pt>
                <c:pt idx="25">
                  <c:v>78</c:v>
                </c:pt>
                <c:pt idx="26">
                  <c:v>67</c:v>
                </c:pt>
                <c:pt idx="27">
                  <c:v>61</c:v>
                </c:pt>
                <c:pt idx="28">
                  <c:v>69</c:v>
                </c:pt>
                <c:pt idx="29">
                  <c:v>67</c:v>
                </c:pt>
                <c:pt idx="30">
                  <c:v>87</c:v>
                </c:pt>
                <c:pt idx="31">
                  <c:v>63</c:v>
                </c:pt>
                <c:pt idx="32">
                  <c:v>67</c:v>
                </c:pt>
                <c:pt idx="33">
                  <c:v>58</c:v>
                </c:pt>
                <c:pt idx="34">
                  <c:v>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D5D-443A-869F-94AA579AD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0601312"/>
        <c:axId val="408378168"/>
      </c:scatterChart>
      <c:valAx>
        <c:axId val="410601312"/>
        <c:scaling>
          <c:orientation val="minMax"/>
          <c:max val="6"/>
          <c:min val="-6"/>
        </c:scaling>
        <c:delete val="0"/>
        <c:axPos val="b"/>
        <c:numFmt formatCode="0_ 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08378168"/>
        <c:crosses val="autoZero"/>
        <c:crossBetween val="midCat"/>
      </c:valAx>
      <c:valAx>
        <c:axId val="408378168"/>
        <c:scaling>
          <c:orientation val="minMax"/>
          <c:max val="100"/>
          <c:min val="4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1"/>
        <c:majorTickMark val="out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10601312"/>
        <c:crossesAt val="-6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5403" cy="337959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9" y="0"/>
            <a:ext cx="4275403" cy="337959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r">
              <a:defRPr sz="1300"/>
            </a:lvl1pPr>
          </a:lstStyle>
          <a:p>
            <a:fld id="{194B3E0B-7118-41BE-862F-DCF5CAE68FF5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11475" y="841375"/>
            <a:ext cx="4043363" cy="22748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57" tIns="47429" rIns="94857" bIns="4742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4857" tIns="47429" rIns="94857" bIns="4742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397806"/>
            <a:ext cx="4275403" cy="337957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9" y="6397806"/>
            <a:ext cx="4275403" cy="337957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r">
              <a:defRPr sz="1300"/>
            </a:lvl1pPr>
          </a:lstStyle>
          <a:p>
            <a:fld id="{2CEC4741-787F-42C1-95C7-D1F8EDFE00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805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Study group</a:t>
            </a:r>
            <a:r>
              <a:rPr lang="ja-JP" altLang="en-US" dirty="0"/>
              <a:t>（</a:t>
            </a:r>
            <a:r>
              <a:rPr lang="en-US" altLang="ja-JP" dirty="0"/>
              <a:t>35</a:t>
            </a:r>
            <a:r>
              <a:rPr lang="ja-JP" altLang="en-US" dirty="0"/>
              <a:t>例）は相関係数 = 0.352, 95%信頼区間 0.0207-0.613, P値 = 0.038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Control group</a:t>
            </a:r>
            <a:r>
              <a:rPr lang="ja-JP" altLang="en-US" dirty="0"/>
              <a:t>（</a:t>
            </a:r>
            <a:r>
              <a:rPr lang="en-US" altLang="ja-JP" dirty="0"/>
              <a:t>70</a:t>
            </a:r>
            <a:r>
              <a:rPr lang="ja-JP" altLang="en-US" dirty="0"/>
              <a:t>例）は相関係数 = -0.268, 95%信頼区間 -0.473--0.0356, P値 = 0.0247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en-US" dirty="0"/>
              <a:t>両群（</a:t>
            </a:r>
            <a:r>
              <a:rPr lang="en-US" altLang="ja-JP" dirty="0"/>
              <a:t>105</a:t>
            </a:r>
            <a:r>
              <a:rPr lang="ja-JP" altLang="en-US" dirty="0"/>
              <a:t>例）を併せた検討結果は相関係数 = -0.128, 95%信頼区間 -0.312-0.0651, P値 = 0.193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EC4741-787F-42C1-95C7-D1F8EDFE003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760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F64EBD-00A3-1BE4-5414-3E98B1C39E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CAE034-3929-2378-A0BE-95BCCE697C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709F9F-CBF1-AEC3-67FB-14CBCB7F8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F73635-6E8A-9479-6B1C-D139200B2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BF29C4-EFF8-2BBB-B4BC-4507D416E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265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EBF81D-2AD7-2E7D-26C1-2EB1B9EB84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39E07EB-8D41-6848-C380-3CF0B2AEC1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754608-9AE6-A29C-8B02-3FC72A3554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2FA026-21D6-11E2-BF6B-514A05E57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F1C5A0-BB3E-6B68-F1A1-21E5E660E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0407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4BDB578-00CF-EED9-0BB7-6D75AF5250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062165E-066C-C629-A294-D9D6F9C58A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A9236F-302D-4831-E289-A446CED04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76314C-D7C2-1937-03A8-5F5D908D49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9BCB95-4174-DC85-74BC-D916E21E9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827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C01F4B-DAB6-A60A-2AA2-A7D4B69952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8416AF6-7E10-98C6-E4B5-DC29F05DF9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BCC66E-BE36-22D1-D8AF-D7E1150957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4D58DA-4E97-AFCE-A400-50D2C0943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1436EC-F935-5A79-C693-4ACCB0047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0638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2BAE5C-07B4-28C3-3C55-07D7943976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C54372-C5EC-9D90-FA9D-5FD80AB7F1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98A9A7-0F78-7F87-68FB-4860057889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2D7CAB-86D6-A743-926D-7D8F641F1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3460398-A615-1CC3-CCE0-A76F7E74E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304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1D7DF5-6740-4078-0E39-B5C1F4F262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F69DE6-006A-E817-7860-1E99C537F6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2654328-3DA1-EBFB-7526-577F3DDE68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F87DCCD-F45E-EA8C-63CD-3B271329E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7DDDCC-F757-A772-2293-800D1A95C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00F0ED-43FE-5599-BA0F-326C07367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2492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3EC29F-056B-F35C-2CB5-1E1F7E230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FEA10D2-5579-2420-BB91-F201795AB7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7117128-EBBC-1D72-3F64-26C78247C0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DFCE12-95F9-2AFE-42A4-7577B814F8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C1A7E8E-D8BE-13EC-C1A2-6C281E1CBB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26A1771-4191-629B-08DD-0F6578CBCB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5C86F34-A154-6DDF-8F51-7E72D47D3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A0B5222-0781-5D36-47C7-CFC7A1923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683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7DD305-63B7-A038-F97F-A5470EE63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24658D5-C09B-05E8-7814-B7927713E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C252A8-46F6-E40B-C233-B1F2425C9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8D856F-6704-BA3E-8DBF-A8DD94677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0007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A52A85A-91D7-028F-6F12-BB4903F63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3EC684C-C6EE-3442-FBBD-F4419DCC9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8337199-B0F6-9AF7-FA71-B4690EFCF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1489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02C5DA-CFA0-D2F6-3A98-124C1095E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DC13A83-D216-4E6E-8411-992325E2A7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693A798-5B54-7141-649F-D37E80D4D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81272CB-3622-D9F7-CD96-AF9DF9571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AE74332-0242-BBB4-C14B-B055BAA5E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607083-4179-4F9C-151B-0F3A081EB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207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827A53-13E0-8555-600D-5B0EF3578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E52BB70-17CD-BFE0-841F-8911362732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54A81B2-2F03-74E6-0A89-F5F4C549AA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69F09A-468D-9B44-17A5-309B51016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602837C-D2CD-2022-9516-14706B16D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AE10D7-22EF-1694-35E4-BE4B4B2F1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788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9B11D38-3698-0EF6-2C3A-A4FD8212B0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B57EFA6-173F-F9E5-7DB1-354582F84A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54A0E8-EAF3-76FB-DF10-6EED05AAC1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58A95-8EE6-4E4F-AA5C-0408D0CAAF83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804E8B-FD44-2AAF-E991-7DE5EA5F9A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1E0DB7-BFDD-7755-664A-457EB80926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C000A-6E2F-45EE-A24E-F380BFF520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498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A29E5E2-9CAF-BC76-5A49-C6900D61BA05}"/>
              </a:ext>
            </a:extLst>
          </p:cNvPr>
          <p:cNvGrpSpPr/>
          <p:nvPr/>
        </p:nvGrpSpPr>
        <p:grpSpPr>
          <a:xfrm>
            <a:off x="1052190" y="360680"/>
            <a:ext cx="10087621" cy="6224339"/>
            <a:chOff x="1953550" y="360680"/>
            <a:chExt cx="10087621" cy="6224339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2676B50E-4AAE-4763-AFD5-FE510C8AD23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39127404"/>
                </p:ext>
              </p:extLst>
            </p:nvPr>
          </p:nvGraphicFramePr>
          <p:xfrm>
            <a:off x="2933195" y="360680"/>
            <a:ext cx="5760000" cy="57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26584BE-81C3-CC7A-4427-AFF8A3A157F4}"/>
                </a:ext>
              </a:extLst>
            </p:cNvPr>
            <p:cNvSpPr txBox="1"/>
            <p:nvPr/>
          </p:nvSpPr>
          <p:spPr>
            <a:xfrm rot="16200000">
              <a:off x="627071" y="3244334"/>
              <a:ext cx="4290700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OS-JR </a:t>
              </a:r>
              <a:r>
                <a:rPr lang="en-US" altLang="ja-JP" sz="1800" b="0" i="0" u="none" strike="noStrike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the final follow-up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9D4F826-8F0E-9018-12E5-621BD81B69F8}"/>
                </a:ext>
              </a:extLst>
            </p:cNvPr>
            <p:cNvSpPr txBox="1"/>
            <p:nvPr/>
          </p:nvSpPr>
          <p:spPr>
            <a:xfrm>
              <a:off x="1953550" y="6215687"/>
              <a:ext cx="7719290" cy="3693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ja-JP" dirty="0">
                  <a:latin typeface="Times New Roman" panose="02020603050405020304" pitchFamily="18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ΔSS at final follow-up – ΔSS at baseline, °</a:t>
              </a:r>
              <a:endPara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AE16CAB-DDDB-2F92-9818-32EC2EA7D75B}"/>
                </a:ext>
              </a:extLst>
            </p:cNvPr>
            <p:cNvSpPr txBox="1"/>
            <p:nvPr/>
          </p:nvSpPr>
          <p:spPr>
            <a:xfrm>
              <a:off x="8441171" y="1192297"/>
              <a:ext cx="3600000" cy="147732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group</a:t>
              </a:r>
            </a:p>
            <a:p>
              <a:pPr algn="ctr"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kumimoji="1" lang="en-US" altLang="ja-JP" sz="180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ashed line, open circles</a:t>
              </a: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 = 1.7x + 69.6</a:t>
              </a:r>
              <a:b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12 (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% CI, 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altLang="ja-JP" sz="1800" b="0" i="0" u="none" strike="noStrike" baseline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– 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13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en-US" altLang="ja-JP" baseline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ja-JP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.038 *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A0F60EE-4B93-29FC-95BE-092F4AA86D59}"/>
                </a:ext>
              </a:extLst>
            </p:cNvPr>
            <p:cNvSpPr txBox="1"/>
            <p:nvPr/>
          </p:nvSpPr>
          <p:spPr>
            <a:xfrm>
              <a:off x="8441171" y="2998312"/>
              <a:ext cx="3600000" cy="147732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group</a:t>
              </a:r>
            </a:p>
            <a:p>
              <a:pPr algn="ctr"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kumimoji="1" lang="en-US" altLang="ja-JP" sz="180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lid line, closed circles</a:t>
              </a:r>
              <a:r>
                <a:rPr kumimoji="1" lang="en-US" altLang="ja-JP" sz="1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ja-JP" altLang="ja-JP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 = -1.1x + 79.5</a:t>
              </a:r>
              <a:b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ja-JP" baseline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07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95% CI, 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473 </a:t>
              </a:r>
              <a:r>
                <a:rPr lang="en-US" altLang="ja-JP" sz="1800" b="0" i="0" u="none" strike="noStrike" baseline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– </a:t>
              </a:r>
              <a:r>
                <a: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0.03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)</a:t>
              </a:r>
              <a:endParaRPr lang="en-US" altLang="ja-JP" baseline="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800" b="0" i="0" u="none" strike="noStrike" kern="1200" baseline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ja-JP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.025 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66340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3</TotalTime>
  <Words>146</Words>
  <Application>Microsoft Office PowerPoint</Application>
  <PresentationFormat>ワイド画面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KAMOTO Yoshinori</dc:creator>
  <cp:lastModifiedBy>OKAMOTO Yoshinori</cp:lastModifiedBy>
  <cp:revision>6</cp:revision>
  <cp:lastPrinted>2025-05-16T09:46:50Z</cp:lastPrinted>
  <dcterms:created xsi:type="dcterms:W3CDTF">2024-12-28T13:59:11Z</dcterms:created>
  <dcterms:modified xsi:type="dcterms:W3CDTF">2025-06-14T07:34:03Z</dcterms:modified>
</cp:coreProperties>
</file>